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5482" autoAdjust="0"/>
  </p:normalViewPr>
  <p:slideViewPr>
    <p:cSldViewPr>
      <p:cViewPr>
        <p:scale>
          <a:sx n="100" d="100"/>
          <a:sy n="100" d="100"/>
        </p:scale>
        <p:origin x="-162" y="142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199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D901F0-4594-4895-9536-AF49D5B8F28C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7887E4-E812-4CFD-9896-807465D6CB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721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7887E4-E812-4CFD-9896-807465D6CB0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82884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403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122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252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6452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820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09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254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94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374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88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927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812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242646" y="8220405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22" name="Rectangle 2"/>
          <p:cNvSpPr>
            <a:spLocks noChangeArrowheads="1"/>
          </p:cNvSpPr>
          <p:nvPr/>
        </p:nvSpPr>
        <p:spPr bwMode="auto">
          <a:xfrm>
            <a:off x="80628" y="6876256"/>
            <a:ext cx="6696744" cy="86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200" b="1" dirty="0"/>
              <a:t>Additional file </a:t>
            </a:r>
            <a:r>
              <a:rPr lang="en-GB" sz="1200" b="1" dirty="0" smtClean="0"/>
              <a:t>5. </a:t>
            </a:r>
            <a:r>
              <a:rPr lang="en-GB" sz="1200" b="1" dirty="0"/>
              <a:t>Individual dexamethasone dose response curves of macrophages isolated from resected lung tissue and BAL. </a:t>
            </a:r>
            <a:r>
              <a:rPr lang="en-GB" sz="1200" dirty="0"/>
              <a:t>Macrophages were isolated from resected lung tissue (black plots) and BAL (red plots) of never smokers (NS; a, d, and g), smokers (S; b, e, and h), and COPD patients (c, f, and </a:t>
            </a:r>
            <a:r>
              <a:rPr lang="en-GB" sz="1200" dirty="0" err="1"/>
              <a:t>i</a:t>
            </a:r>
            <a:r>
              <a:rPr lang="en-GB" sz="1200" dirty="0"/>
              <a:t>). Supernatants were analysed for TNF-α (a, b, and c), IL-6 (d, e, and f), and CXCL8 (g, h, and </a:t>
            </a:r>
            <a:r>
              <a:rPr lang="en-GB" sz="1200" dirty="0" err="1"/>
              <a:t>i</a:t>
            </a:r>
            <a:r>
              <a:rPr lang="en-GB" sz="1200" dirty="0"/>
              <a:t>).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-171450" y="611560"/>
            <a:ext cx="7318375" cy="5905128"/>
            <a:chOff x="-171450" y="611560"/>
            <a:chExt cx="7318375" cy="5905128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34042320"/>
                </p:ext>
              </p:extLst>
            </p:nvPr>
          </p:nvGraphicFramePr>
          <p:xfrm>
            <a:off x="-171450" y="684213"/>
            <a:ext cx="7318375" cy="5832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56" name="Prism 6" r:id="rId4" imgW="6621095" imgH="5276977" progId="Prism6.Document">
                    <p:embed/>
                  </p:oleObj>
                </mc:Choice>
                <mc:Fallback>
                  <p:oleObj name="Prism 6" r:id="rId4" imgW="6621095" imgH="5276977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171450" y="684213"/>
                          <a:ext cx="7318375" cy="58324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-27384" y="611560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a</a:t>
              </a:r>
              <a:endParaRPr lang="en-GB" sz="16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304256" y="613537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b</a:t>
              </a:r>
              <a:endParaRPr lang="en-GB" sz="1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680520" y="613537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c</a:t>
              </a:r>
              <a:endParaRPr lang="en-GB" sz="16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-27384" y="257528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d</a:t>
              </a:r>
              <a:endParaRPr lang="en-GB" sz="16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04256" y="257726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e</a:t>
              </a:r>
              <a:endParaRPr lang="en-GB" sz="16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752528" y="257726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f</a:t>
              </a:r>
              <a:endParaRPr lang="en-GB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-27384" y="449999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g</a:t>
              </a:r>
              <a:endParaRPr lang="en-GB" sz="16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376264" y="453100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h</a:t>
              </a:r>
              <a:endParaRPr lang="en-GB" sz="16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752528" y="453100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err="1" smtClean="0"/>
                <a:t>i</a:t>
              </a:r>
              <a:endParaRPr lang="en-GB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630595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27</TotalTime>
  <Words>113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Higham</dc:creator>
  <cp:lastModifiedBy>Andrew Higham</cp:lastModifiedBy>
  <cp:revision>112</cp:revision>
  <dcterms:created xsi:type="dcterms:W3CDTF">2014-07-22T13:15:53Z</dcterms:created>
  <dcterms:modified xsi:type="dcterms:W3CDTF">2015-06-11T10:10:14Z</dcterms:modified>
</cp:coreProperties>
</file>